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9" r:id="rId3"/>
    <p:sldId id="261" r:id="rId4"/>
    <p:sldId id="260" r:id="rId5"/>
    <p:sldId id="257" r:id="rId6"/>
    <p:sldId id="258" r:id="rId7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67"/>
    <p:restoredTop sz="94640"/>
  </p:normalViewPr>
  <p:slideViewPr>
    <p:cSldViewPr snapToGrid="0">
      <p:cViewPr>
        <p:scale>
          <a:sx n="78" d="100"/>
          <a:sy n="78" d="100"/>
        </p:scale>
        <p:origin x="334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C793B-D979-024B-8877-071AD984D196}" type="datetimeFigureOut">
              <a:rPr lang="en-US" smtClean="0"/>
              <a:t>3/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0E14C-331F-614B-84AF-F6884ED6B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497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C793B-D979-024B-8877-071AD984D196}" type="datetimeFigureOut">
              <a:rPr lang="en-US" smtClean="0"/>
              <a:t>3/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0E14C-331F-614B-84AF-F6884ED6B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145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C793B-D979-024B-8877-071AD984D196}" type="datetimeFigureOut">
              <a:rPr lang="en-US" smtClean="0"/>
              <a:t>3/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0E14C-331F-614B-84AF-F6884ED6B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7329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C793B-D979-024B-8877-071AD984D196}" type="datetimeFigureOut">
              <a:rPr lang="en-US" smtClean="0"/>
              <a:t>3/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0E14C-331F-614B-84AF-F6884ED6B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5934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C793B-D979-024B-8877-071AD984D196}" type="datetimeFigureOut">
              <a:rPr lang="en-US" smtClean="0"/>
              <a:t>3/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0E14C-331F-614B-84AF-F6884ED6B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874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C793B-D979-024B-8877-071AD984D196}" type="datetimeFigureOut">
              <a:rPr lang="en-US" smtClean="0"/>
              <a:t>3/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0E14C-331F-614B-84AF-F6884ED6B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8800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C793B-D979-024B-8877-071AD984D196}" type="datetimeFigureOut">
              <a:rPr lang="en-US" smtClean="0"/>
              <a:t>3/1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0E14C-331F-614B-84AF-F6884ED6B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843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C793B-D979-024B-8877-071AD984D196}" type="datetimeFigureOut">
              <a:rPr lang="en-US" smtClean="0"/>
              <a:t>3/1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0E14C-331F-614B-84AF-F6884ED6B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007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C793B-D979-024B-8877-071AD984D196}" type="datetimeFigureOut">
              <a:rPr lang="en-US" smtClean="0"/>
              <a:t>3/1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0E14C-331F-614B-84AF-F6884ED6B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068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C793B-D979-024B-8877-071AD984D196}" type="datetimeFigureOut">
              <a:rPr lang="en-US" smtClean="0"/>
              <a:t>3/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0E14C-331F-614B-84AF-F6884ED6B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737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C793B-D979-024B-8877-071AD984D196}" type="datetimeFigureOut">
              <a:rPr lang="en-US" smtClean="0"/>
              <a:t>3/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0E14C-331F-614B-84AF-F6884ED6B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455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1C793B-D979-024B-8877-071AD984D196}" type="datetimeFigureOut">
              <a:rPr lang="en-US" smtClean="0"/>
              <a:t>3/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D40E14C-331F-614B-84AF-F6884ED6B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542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graph showing a number of different points&#10;&#10;AI-generated content may be incorrect.">
            <a:extLst>
              <a:ext uri="{FF2B5EF4-FFF2-40B4-BE49-F238E27FC236}">
                <a16:creationId xmlns:a16="http://schemas.microsoft.com/office/drawing/2014/main" id="{65432A3B-F891-35E6-215F-E4B2100DA1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334776"/>
            <a:ext cx="2035248" cy="2901603"/>
          </a:xfrm>
          <a:prstGeom prst="rect">
            <a:avLst/>
          </a:prstGeom>
        </p:spPr>
      </p:pic>
      <p:pic>
        <p:nvPicPr>
          <p:cNvPr id="11" name="Picture 10" descr="A graph showing the number of different points&#10;&#10;AI-generated content may be incorrect.">
            <a:extLst>
              <a:ext uri="{FF2B5EF4-FFF2-40B4-BE49-F238E27FC236}">
                <a16:creationId xmlns:a16="http://schemas.microsoft.com/office/drawing/2014/main" id="{1CB6CDA7-1778-06FD-3EEC-397E6533091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3350" y="6898144"/>
            <a:ext cx="2120406" cy="3023011"/>
          </a:xfrm>
          <a:prstGeom prst="rect">
            <a:avLst/>
          </a:prstGeom>
        </p:spPr>
      </p:pic>
      <p:pic>
        <p:nvPicPr>
          <p:cNvPr id="13" name="Picture 12" descr="A graph showing the amount of a number of dots&#10;&#10;AI-generated content may be incorrect.">
            <a:extLst>
              <a:ext uri="{FF2B5EF4-FFF2-40B4-BE49-F238E27FC236}">
                <a16:creationId xmlns:a16="http://schemas.microsoft.com/office/drawing/2014/main" id="{1A38F93C-D0E5-CE06-7370-36AF0B3FE6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3292" y="6842409"/>
            <a:ext cx="2260531" cy="3278519"/>
          </a:xfrm>
          <a:prstGeom prst="rect">
            <a:avLst/>
          </a:prstGeom>
        </p:spPr>
      </p:pic>
      <p:pic>
        <p:nvPicPr>
          <p:cNvPr id="15" name="Picture 14" descr="A diagram of a b-wave frequency&#10;&#10;AI-generated content may be incorrect.">
            <a:extLst>
              <a:ext uri="{FF2B5EF4-FFF2-40B4-BE49-F238E27FC236}">
                <a16:creationId xmlns:a16="http://schemas.microsoft.com/office/drawing/2014/main" id="{61E0DE88-7A1D-ABB0-4E48-95C8605F7F2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3921" y="3649408"/>
            <a:ext cx="2100496" cy="2921221"/>
          </a:xfrm>
          <a:prstGeom prst="rect">
            <a:avLst/>
          </a:prstGeom>
        </p:spPr>
      </p:pic>
      <p:pic>
        <p:nvPicPr>
          <p:cNvPr id="17" name="Picture 16" descr="A diagram of a graph&#10;&#10;AI-generated content may be incorrect.">
            <a:extLst>
              <a:ext uri="{FF2B5EF4-FFF2-40B4-BE49-F238E27FC236}">
                <a16:creationId xmlns:a16="http://schemas.microsoft.com/office/drawing/2014/main" id="{A0857E8B-BBD0-992E-7A10-D64E04BB5CB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3886" y="240763"/>
            <a:ext cx="2260531" cy="3296002"/>
          </a:xfrm>
          <a:prstGeom prst="rect">
            <a:avLst/>
          </a:prstGeom>
        </p:spPr>
      </p:pic>
      <p:pic>
        <p:nvPicPr>
          <p:cNvPr id="19" name="Picture 18" descr="A graph showing the number of different types of eye level&#10;&#10;AI-generated content may be incorrect.">
            <a:extLst>
              <a:ext uri="{FF2B5EF4-FFF2-40B4-BE49-F238E27FC236}">
                <a16:creationId xmlns:a16="http://schemas.microsoft.com/office/drawing/2014/main" id="{4EFD95A9-E91F-FAF2-F1C8-7633D8E1B88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29000" y="3547618"/>
            <a:ext cx="2100496" cy="3023011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4BE8D371-2132-39F4-8F2C-ADB3C57E350B}"/>
              </a:ext>
            </a:extLst>
          </p:cNvPr>
          <p:cNvSpPr txBox="1"/>
          <p:nvPr/>
        </p:nvSpPr>
        <p:spPr>
          <a:xfrm>
            <a:off x="659295" y="10392708"/>
            <a:ext cx="55394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S1</a:t>
            </a:r>
            <a:r>
              <a:rPr lang="en-US" dirty="0"/>
              <a:t>. Eye level ERG results from both flash and flicker paradigms</a:t>
            </a:r>
          </a:p>
        </p:txBody>
      </p:sp>
    </p:spTree>
    <p:extLst>
      <p:ext uri="{BB962C8B-B14F-4D97-AF65-F5344CB8AC3E}">
        <p14:creationId xmlns:p14="http://schemas.microsoft.com/office/powerpoint/2010/main" val="30306645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E6AC064-98B5-95F7-435A-A86C215F857E}"/>
              </a:ext>
            </a:extLst>
          </p:cNvPr>
          <p:cNvGrpSpPr/>
          <p:nvPr/>
        </p:nvGrpSpPr>
        <p:grpSpPr>
          <a:xfrm>
            <a:off x="374015" y="453556"/>
            <a:ext cx="6109970" cy="4526280"/>
            <a:chOff x="0" y="0"/>
            <a:chExt cx="6110599" cy="4526526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2AC7B64-3C70-48D0-BF75-6156711F991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1935480" cy="22987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69E552A-978A-0CD7-2A73-746E10BB073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36618" y="0"/>
              <a:ext cx="1875790" cy="218059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BAE747A8-4D4C-1DA0-6323-3BFD4C825BA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91754" y="0"/>
              <a:ext cx="1864360" cy="2234565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AB3FAAE-55AE-8DD5-EDD9-2FCB9DFB4BD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2428" y="2299581"/>
              <a:ext cx="1864995" cy="2226945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0799BB9A-4CEA-2E34-B086-D412EB7FDAC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209046" y="2299581"/>
              <a:ext cx="1857375" cy="2226945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B2345C1E-6ECC-48F5-5836-4EAAA444905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255129" y="2344848"/>
              <a:ext cx="1855470" cy="2179320"/>
            </a:xfrm>
            <a:prstGeom prst="rect">
              <a:avLst/>
            </a:prstGeom>
          </p:spPr>
        </p:pic>
      </p:grp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C5131F49-236E-6792-A078-4288E4BFD4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7619997"/>
              </p:ext>
            </p:extLst>
          </p:nvPr>
        </p:nvGraphicFramePr>
        <p:xfrm>
          <a:off x="374015" y="5501127"/>
          <a:ext cx="6109969" cy="4172208"/>
        </p:xfrm>
        <a:graphic>
          <a:graphicData uri="http://schemas.openxmlformats.org/drawingml/2006/table">
            <a:tbl>
              <a:tblPr firstRow="1" firstCol="1" bandRow="1"/>
              <a:tblGrid>
                <a:gridCol w="2309866">
                  <a:extLst>
                    <a:ext uri="{9D8B030D-6E8A-4147-A177-3AD203B41FA5}">
                      <a16:colId xmlns:a16="http://schemas.microsoft.com/office/drawing/2014/main" val="3621169760"/>
                    </a:ext>
                  </a:extLst>
                </a:gridCol>
                <a:gridCol w="1266701">
                  <a:extLst>
                    <a:ext uri="{9D8B030D-6E8A-4147-A177-3AD203B41FA5}">
                      <a16:colId xmlns:a16="http://schemas.microsoft.com/office/drawing/2014/main" val="2388703580"/>
                    </a:ext>
                  </a:extLst>
                </a:gridCol>
                <a:gridCol w="1266701">
                  <a:extLst>
                    <a:ext uri="{9D8B030D-6E8A-4147-A177-3AD203B41FA5}">
                      <a16:colId xmlns:a16="http://schemas.microsoft.com/office/drawing/2014/main" val="2106772341"/>
                    </a:ext>
                  </a:extLst>
                </a:gridCol>
                <a:gridCol w="1266701">
                  <a:extLst>
                    <a:ext uri="{9D8B030D-6E8A-4147-A177-3AD203B41FA5}">
                      <a16:colId xmlns:a16="http://schemas.microsoft.com/office/drawing/2014/main" val="2468639813"/>
                    </a:ext>
                  </a:extLst>
                </a:gridCol>
              </a:tblGrid>
              <a:tr h="733083"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ABC</a:t>
                      </a:r>
                      <a:r>
                        <a:rPr lang="en-US" sz="1400" b="1" kern="100" baseline="-25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FX</a:t>
                      </a: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 Domain (Maximum Score) 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Good Electrode Placement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Poor Electrode Placement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b="1" i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p</a:t>
                      </a: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-value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4015332"/>
                  </a:ext>
                </a:extLst>
              </a:tr>
              <a:tr h="33617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(≤4 mm) 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(&gt;4 mm) 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8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9723288"/>
                  </a:ext>
                </a:extLst>
              </a:tr>
              <a:tr h="336171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Irritability (54) 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5 [0.0-3.0]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4.5 [1.0-9.0]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0701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5004718"/>
                  </a:ext>
                </a:extLst>
              </a:tr>
              <a:tr h="336171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Hyperactivity (27) 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2.0 [2.0-5.0]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4.0 [2.0-7.0]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2005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6966839"/>
                  </a:ext>
                </a:extLst>
              </a:tr>
              <a:tr h="336171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Lethargy (42) 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1.0 [0.0-2.0]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3.0 [1.0-7.0]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1617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3541001"/>
                  </a:ext>
                </a:extLst>
              </a:tr>
              <a:tr h="336171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Stereotypy (18) 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0 [0.0-1.0]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2.5 [0.0-5.0]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2023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5919221"/>
                  </a:ext>
                </a:extLst>
              </a:tr>
              <a:tr h="336171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Inappropriate Speech (12) 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3.0 [1.0-8.0]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3.0 [2.0-5.0]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9849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553671"/>
                  </a:ext>
                </a:extLst>
              </a:tr>
              <a:tr h="336171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Social Avoidance (12) 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0 [0.0-6.0]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4.0 [1.0-7.0]</a:t>
                      </a:r>
                      <a:endParaRPr lang="en-US" sz="18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buNone/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1919</a:t>
                      </a:r>
                      <a:endParaRPr lang="en-US" sz="18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4921" marR="6492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2646066"/>
                  </a:ext>
                </a:extLst>
              </a:tr>
            </a:tbl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224B80E2-5C6B-6D06-625C-BCAE24675D77}"/>
              </a:ext>
            </a:extLst>
          </p:cNvPr>
          <p:cNvSpPr txBox="1"/>
          <p:nvPr/>
        </p:nvSpPr>
        <p:spPr>
          <a:xfrm>
            <a:off x="630721" y="10194114"/>
            <a:ext cx="559655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S2</a:t>
            </a:r>
            <a:r>
              <a:rPr lang="en-US" dirty="0"/>
              <a:t>. Electrode placement and ABC</a:t>
            </a:r>
            <a:r>
              <a:rPr lang="en-US" baseline="-25000" dirty="0"/>
              <a:t>FX</a:t>
            </a:r>
            <a:r>
              <a:rPr lang="en-US" dirty="0"/>
              <a:t> domains, including irritability (A), hyperactivity (B), lethargy (C), stereotypy (D), inappropriate speech (E), social withdrawal (F)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459270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2">
            <a:extLst>
              <a:ext uri="{FF2B5EF4-FFF2-40B4-BE49-F238E27FC236}">
                <a16:creationId xmlns:a16="http://schemas.microsoft.com/office/drawing/2014/main" id="{76552623-1F10-DEA6-F978-2313B5550C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4389" y="7805061"/>
            <a:ext cx="5915025" cy="2356556"/>
          </a:xfrm>
          <a:prstGeom prst="rect">
            <a:avLst/>
          </a:prstGeom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lIns="91440" tIns="45720" rIns="91440" bIns="45720" numCol="1" rtlCol="0" anchor="ctr" anchorCtr="0" compatLnSpc="1">
            <a:prstTxWarp prst="textNoShape">
              <a:avLst/>
            </a:prstTxWarp>
            <a:normAutofit/>
          </a:bodyPr>
          <a:lstStyle/>
          <a:p>
            <a:pPr marL="0" marR="0" lvl="0" indent="0" defTabSz="685800" fontAlgn="base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  <a:buClrTx/>
              <a:buSzTx/>
              <a:tabLst/>
            </a:pPr>
            <a:r>
              <a:rPr kumimoji="0" lang="en-US" altLang="en-US" b="1" i="0" u="none" strike="noStrike" kern="1200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+mj-ea"/>
                <a:cs typeface="+mj-cs"/>
              </a:rPr>
              <a:t>Supplementary Table S1</a:t>
            </a:r>
            <a:r>
              <a:rPr kumimoji="0" lang="en-US" altLang="en-US" b="0" i="0" u="none" strike="noStrike" kern="1200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+mj-ea"/>
                <a:cs typeface="+mj-cs"/>
              </a:rPr>
              <a:t>. Spearman correlations between ERG parameters and ABC</a:t>
            </a:r>
            <a:r>
              <a:rPr kumimoji="0" lang="en-US" altLang="en-US" b="0" i="0" u="none" strike="noStrike" kern="1200" cap="none" normalizeH="0" baseline="-30000" dirty="0">
                <a:ln>
                  <a:noFill/>
                </a:ln>
                <a:effectLst/>
                <a:latin typeface="Aptos" panose="020B0004020202020204" pitchFamily="34" charset="0"/>
                <a:ea typeface="+mj-ea"/>
                <a:cs typeface="+mj-cs"/>
              </a:rPr>
              <a:t>FX</a:t>
            </a:r>
            <a:r>
              <a:rPr kumimoji="0" lang="en-US" altLang="en-US" b="0" i="0" u="none" strike="noStrike" kern="1200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+mj-ea"/>
                <a:cs typeface="+mj-cs"/>
              </a:rPr>
              <a:t> domain scores in individuals with Fragile X syndrome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35AFF708-8BE1-C68A-1C7E-315E338054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3507206"/>
              </p:ext>
            </p:extLst>
          </p:nvPr>
        </p:nvGraphicFramePr>
        <p:xfrm>
          <a:off x="264973" y="208441"/>
          <a:ext cx="6119497" cy="8158566"/>
        </p:xfrm>
        <a:graphic>
          <a:graphicData uri="http://schemas.openxmlformats.org/drawingml/2006/table">
            <a:tbl>
              <a:tblPr firstRow="1" firstCol="1" bandRow="1"/>
              <a:tblGrid>
                <a:gridCol w="2135327">
                  <a:extLst>
                    <a:ext uri="{9D8B030D-6E8A-4147-A177-3AD203B41FA5}">
                      <a16:colId xmlns:a16="http://schemas.microsoft.com/office/drawing/2014/main" val="2564952560"/>
                    </a:ext>
                  </a:extLst>
                </a:gridCol>
                <a:gridCol w="1533941">
                  <a:extLst>
                    <a:ext uri="{9D8B030D-6E8A-4147-A177-3AD203B41FA5}">
                      <a16:colId xmlns:a16="http://schemas.microsoft.com/office/drawing/2014/main" val="1929317129"/>
                    </a:ext>
                  </a:extLst>
                </a:gridCol>
                <a:gridCol w="1237043">
                  <a:extLst>
                    <a:ext uri="{9D8B030D-6E8A-4147-A177-3AD203B41FA5}">
                      <a16:colId xmlns:a16="http://schemas.microsoft.com/office/drawing/2014/main" val="2272483720"/>
                    </a:ext>
                  </a:extLst>
                </a:gridCol>
                <a:gridCol w="1213186">
                  <a:extLst>
                    <a:ext uri="{9D8B030D-6E8A-4147-A177-3AD203B41FA5}">
                      <a16:colId xmlns:a16="http://schemas.microsoft.com/office/drawing/2014/main" val="1041325194"/>
                    </a:ext>
                  </a:extLst>
                </a:gridCol>
              </a:tblGrid>
              <a:tr h="337266"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1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ERG parameter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1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ABC</a:t>
                      </a:r>
                      <a:r>
                        <a:rPr lang="en-US" sz="1100" b="1" i="0" u="none" strike="noStrike" kern="100" baseline="-25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FX</a:t>
                      </a:r>
                      <a:r>
                        <a:rPr lang="en-US" sz="1100" b="1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 domain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1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Spearman </a:t>
                      </a:r>
                      <a:r>
                        <a:rPr lang="el-GR" sz="1100" b="1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ρ</a:t>
                      </a:r>
                      <a:endParaRPr lang="el-GR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1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p-value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3721827"/>
                  </a:ext>
                </a:extLst>
              </a:tr>
              <a:tr h="633762"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1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Flash b-wave amplitude (µV)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Hyperactivity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−0.10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73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9007714"/>
                  </a:ext>
                </a:extLst>
              </a:tr>
              <a:tr h="337266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Irritability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−0.06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84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3718488"/>
                  </a:ext>
                </a:extLst>
              </a:tr>
              <a:tr h="6337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Lethargy/Social Withdrawal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−0.05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87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1824952"/>
                  </a:ext>
                </a:extLst>
              </a:tr>
              <a:tr h="337266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Stereotypy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−0.04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9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3854785"/>
                  </a:ext>
                </a:extLst>
              </a:tr>
              <a:tr h="337266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Inappropriate Speech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−0.15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59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5640120"/>
                  </a:ext>
                </a:extLst>
              </a:tr>
              <a:tr h="337266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Social Avoidance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−0.15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58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7189742"/>
                  </a:ext>
                </a:extLst>
              </a:tr>
              <a:tr h="633762"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1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Flash b-wave time-to-peak (ms)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Hyperactivity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−0.34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24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1720792"/>
                  </a:ext>
                </a:extLst>
              </a:tr>
              <a:tr h="337266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Irritability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−0.29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31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87773266"/>
                  </a:ext>
                </a:extLst>
              </a:tr>
              <a:tr h="6337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Lethargy/Social Withdrawal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−0.38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18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7366751"/>
                  </a:ext>
                </a:extLst>
              </a:tr>
              <a:tr h="337266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Stereotypy</a:t>
                      </a:r>
                      <a:endParaRPr lang="en-US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−0.44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12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0206928"/>
                  </a:ext>
                </a:extLst>
              </a:tr>
              <a:tr h="337266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Inappropriate Speech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−0.09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77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0817457"/>
                  </a:ext>
                </a:extLst>
              </a:tr>
              <a:tr h="337266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Social Avoidance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−0.16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6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166759"/>
                  </a:ext>
                </a:extLst>
              </a:tr>
              <a:tr h="337266"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1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Flicker time-to-peak (ms)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Hyperactivity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63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1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7884171"/>
                  </a:ext>
                </a:extLst>
              </a:tr>
              <a:tr h="337266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Irritability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−0.04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93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5761815"/>
                  </a:ext>
                </a:extLst>
              </a:tr>
              <a:tr h="6337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Lethargy/Social Withdrawal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31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46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2619079"/>
                  </a:ext>
                </a:extLst>
              </a:tr>
              <a:tr h="337266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Stereotypy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−0.25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56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6677223"/>
                  </a:ext>
                </a:extLst>
              </a:tr>
              <a:tr h="337266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Inappropriate Speech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26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53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3224706"/>
                  </a:ext>
                </a:extLst>
              </a:tr>
              <a:tr h="337266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Social Avoidance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−0.43</a:t>
                      </a:r>
                      <a:endParaRPr lang="en-US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 fontAlgn="t">
                        <a:lnSpc>
                          <a:spcPct val="200000"/>
                        </a:lnSpc>
                        <a:buNone/>
                      </a:pPr>
                      <a:r>
                        <a:rPr lang="en-US" sz="1100" b="0" i="0" u="none" strike="noStrike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0.29</a:t>
                      </a:r>
                      <a:endParaRPr lang="en-US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457" marR="59457" marT="825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031058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568598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5AB949C-FC87-7C71-D668-313F845160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5750362"/>
              </p:ext>
            </p:extLst>
          </p:nvPr>
        </p:nvGraphicFramePr>
        <p:xfrm>
          <a:off x="412474" y="1392271"/>
          <a:ext cx="5869056" cy="4948895"/>
        </p:xfrm>
        <a:graphic>
          <a:graphicData uri="http://schemas.openxmlformats.org/drawingml/2006/table">
            <a:tbl>
              <a:tblPr/>
              <a:tblGrid>
                <a:gridCol w="2269368">
                  <a:extLst>
                    <a:ext uri="{9D8B030D-6E8A-4147-A177-3AD203B41FA5}">
                      <a16:colId xmlns:a16="http://schemas.microsoft.com/office/drawing/2014/main" val="3932363781"/>
                    </a:ext>
                  </a:extLst>
                </a:gridCol>
                <a:gridCol w="1799844">
                  <a:extLst>
                    <a:ext uri="{9D8B030D-6E8A-4147-A177-3AD203B41FA5}">
                      <a16:colId xmlns:a16="http://schemas.microsoft.com/office/drawing/2014/main" val="4114252755"/>
                    </a:ext>
                  </a:extLst>
                </a:gridCol>
                <a:gridCol w="1799844">
                  <a:extLst>
                    <a:ext uri="{9D8B030D-6E8A-4147-A177-3AD203B41FA5}">
                      <a16:colId xmlns:a16="http://schemas.microsoft.com/office/drawing/2014/main" val="534679071"/>
                    </a:ext>
                  </a:extLst>
                </a:gridCol>
              </a:tblGrid>
              <a:tr h="70698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easure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ontrol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FXS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1374401"/>
                  </a:ext>
                </a:extLst>
              </a:tr>
              <a:tr h="70698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-wave amplitude (µV)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−5.38 ± 2.22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−5.00 ± 2.89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3118827"/>
                  </a:ext>
                </a:extLst>
              </a:tr>
              <a:tr h="70698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-wave time-to-peak (ms)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1.24 ± 1.60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2.94 ± 2.85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9512269"/>
                  </a:ext>
                </a:extLst>
              </a:tr>
              <a:tr h="70698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B-wave amplitude (µV)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0.86 ± 8.98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5.75 ± 5.45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1365751"/>
                  </a:ext>
                </a:extLst>
              </a:tr>
              <a:tr h="70698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B-wave time-to-peak (ms)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7.69 ± 0.96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9.06 ± 1.53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0409463"/>
                  </a:ext>
                </a:extLst>
              </a:tr>
              <a:tr h="70698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Flicker amplitude (µV)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1.59 ± 6.31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5.33 ± 8.11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5390583"/>
                  </a:ext>
                </a:extLst>
              </a:tr>
              <a:tr h="70698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Flicker time-to-peak (ms)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4.20 ± 0.62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6.21 ± 2.49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1180076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214ED89-307F-2697-F393-695B4DE07060}"/>
              </a:ext>
            </a:extLst>
          </p:cNvPr>
          <p:cNvSpPr txBox="1"/>
          <p:nvPr/>
        </p:nvSpPr>
        <p:spPr>
          <a:xfrm>
            <a:off x="412474" y="6520070"/>
            <a:ext cx="586905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Table S2</a:t>
            </a:r>
            <a:r>
              <a:rPr lang="en-US" dirty="0"/>
              <a:t>. Light-Adapted ERG Amplitude and Time-to-Peak Measures.</a:t>
            </a:r>
          </a:p>
          <a:p>
            <a:endParaRPr lang="en-US" dirty="0"/>
          </a:p>
          <a:p>
            <a:r>
              <a:rPr lang="en-US" i="1" dirty="0"/>
              <a:t>Note</a:t>
            </a:r>
            <a:r>
              <a:rPr lang="en-US" dirty="0"/>
              <a:t>. Values are reported as mean ± SD.</a:t>
            </a:r>
          </a:p>
        </p:txBody>
      </p:sp>
    </p:spTree>
    <p:extLst>
      <p:ext uri="{BB962C8B-B14F-4D97-AF65-F5344CB8AC3E}">
        <p14:creationId xmlns:p14="http://schemas.microsoft.com/office/powerpoint/2010/main" val="23872290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EC874F5-F8FE-4F5F-92D4-154A567A44F3}"/>
              </a:ext>
            </a:extLst>
          </p:cNvPr>
          <p:cNvSpPr txBox="1"/>
          <p:nvPr/>
        </p:nvSpPr>
        <p:spPr>
          <a:xfrm>
            <a:off x="387626" y="6096001"/>
            <a:ext cx="6197048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Table S3</a:t>
            </a:r>
            <a:r>
              <a:rPr lang="en-US" dirty="0"/>
              <a:t>. Left- and Right-Eye Feasibility for Flash B-Wave Amplitude in FXS</a:t>
            </a:r>
          </a:p>
          <a:p>
            <a:endParaRPr lang="en-US" dirty="0"/>
          </a:p>
          <a:p>
            <a:endParaRPr lang="en-US" dirty="0"/>
          </a:p>
          <a:p>
            <a:r>
              <a:rPr lang="en-US" i="1" dirty="0"/>
              <a:t>Note</a:t>
            </a:r>
            <a:r>
              <a:rPr lang="en-US" dirty="0"/>
              <a:t>. Fisher exact testing demonstrated no significant differences between right and left eyes in acquisition rate (OR = 1.40, p = 0.77) or success rates (OR = 1.00, p = 1.00).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0ECBCD9F-68D7-36C1-5CBC-0E44590F58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4451523"/>
              </p:ext>
            </p:extLst>
          </p:nvPr>
        </p:nvGraphicFramePr>
        <p:xfrm>
          <a:off x="273326" y="3577496"/>
          <a:ext cx="6311348" cy="235738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593459">
                  <a:extLst>
                    <a:ext uri="{9D8B030D-6E8A-4147-A177-3AD203B41FA5}">
                      <a16:colId xmlns:a16="http://schemas.microsoft.com/office/drawing/2014/main" val="1271427573"/>
                    </a:ext>
                  </a:extLst>
                </a:gridCol>
                <a:gridCol w="1593459">
                  <a:extLst>
                    <a:ext uri="{9D8B030D-6E8A-4147-A177-3AD203B41FA5}">
                      <a16:colId xmlns:a16="http://schemas.microsoft.com/office/drawing/2014/main" val="3203557192"/>
                    </a:ext>
                  </a:extLst>
                </a:gridCol>
                <a:gridCol w="1562215">
                  <a:extLst>
                    <a:ext uri="{9D8B030D-6E8A-4147-A177-3AD203B41FA5}">
                      <a16:colId xmlns:a16="http://schemas.microsoft.com/office/drawing/2014/main" val="2514103375"/>
                    </a:ext>
                  </a:extLst>
                </a:gridCol>
                <a:gridCol w="1562215">
                  <a:extLst>
                    <a:ext uri="{9D8B030D-6E8A-4147-A177-3AD203B41FA5}">
                      <a16:colId xmlns:a16="http://schemas.microsoft.com/office/drawing/2014/main" val="3251911336"/>
                    </a:ext>
                  </a:extLst>
                </a:gridCol>
              </a:tblGrid>
              <a:tr h="36144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Eye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Total eyes (n)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Acquisition n (%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Success n (%)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extLst>
                  <a:ext uri="{0D108BD9-81ED-4DB2-BD59-A6C34878D82A}">
                    <a16:rowId xmlns:a16="http://schemas.microsoft.com/office/drawing/2014/main" val="1061821175"/>
                  </a:ext>
                </a:extLst>
              </a:tr>
              <a:tr h="36144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Right eye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24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13 / 24 (54%)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8 / 24 (33%)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extLst>
                  <a:ext uri="{0D108BD9-81ED-4DB2-BD59-A6C34878D82A}">
                    <a16:rowId xmlns:a16="http://schemas.microsoft.com/office/drawing/2014/main" val="535828278"/>
                  </a:ext>
                </a:extLst>
              </a:tr>
              <a:tr h="36144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Left eye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4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11 / 24 (46%)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8 / 24 (33%)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extLst>
                  <a:ext uri="{0D108BD9-81ED-4DB2-BD59-A6C34878D82A}">
                    <a16:rowId xmlns:a16="http://schemas.microsoft.com/office/drawing/2014/main" val="2594938248"/>
                  </a:ext>
                </a:extLst>
              </a:tr>
              <a:tr h="63903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Either eye (eye-level total)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48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3 / 48 (48%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6 / 48 (33%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extLst>
                  <a:ext uri="{0D108BD9-81ED-4DB2-BD59-A6C34878D82A}">
                    <a16:rowId xmlns:a16="http://schemas.microsoft.com/office/drawing/2014/main" val="2232288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770178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676383C-1093-B656-7A55-FB49B9B8220D}"/>
              </a:ext>
            </a:extLst>
          </p:cNvPr>
          <p:cNvSpPr txBox="1"/>
          <p:nvPr/>
        </p:nvSpPr>
        <p:spPr>
          <a:xfrm>
            <a:off x="387626" y="6096001"/>
            <a:ext cx="61970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Table S4</a:t>
            </a:r>
            <a:r>
              <a:rPr lang="en-US" dirty="0"/>
              <a:t>. Left- and Right-Eye Feasibility for Flicker Amplitude in FXS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E430D6FF-8AC8-DEF5-FAFC-46B7E6A8B92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8144620"/>
              </p:ext>
            </p:extLst>
          </p:nvPr>
        </p:nvGraphicFramePr>
        <p:xfrm>
          <a:off x="189948" y="3550111"/>
          <a:ext cx="6478104" cy="2424456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635561">
                  <a:extLst>
                    <a:ext uri="{9D8B030D-6E8A-4147-A177-3AD203B41FA5}">
                      <a16:colId xmlns:a16="http://schemas.microsoft.com/office/drawing/2014/main" val="4046585559"/>
                    </a:ext>
                  </a:extLst>
                </a:gridCol>
                <a:gridCol w="1635561">
                  <a:extLst>
                    <a:ext uri="{9D8B030D-6E8A-4147-A177-3AD203B41FA5}">
                      <a16:colId xmlns:a16="http://schemas.microsoft.com/office/drawing/2014/main" val="3333912919"/>
                    </a:ext>
                  </a:extLst>
                </a:gridCol>
                <a:gridCol w="1603491">
                  <a:extLst>
                    <a:ext uri="{9D8B030D-6E8A-4147-A177-3AD203B41FA5}">
                      <a16:colId xmlns:a16="http://schemas.microsoft.com/office/drawing/2014/main" val="3039457112"/>
                    </a:ext>
                  </a:extLst>
                </a:gridCol>
                <a:gridCol w="1603491">
                  <a:extLst>
                    <a:ext uri="{9D8B030D-6E8A-4147-A177-3AD203B41FA5}">
                      <a16:colId xmlns:a16="http://schemas.microsoft.com/office/drawing/2014/main" val="1248021480"/>
                    </a:ext>
                  </a:extLst>
                </a:gridCol>
              </a:tblGrid>
              <a:tr h="394983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Eye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Total eyes (n)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Acquisition n (%)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Success n (%)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extLst>
                  <a:ext uri="{0D108BD9-81ED-4DB2-BD59-A6C34878D82A}">
                    <a16:rowId xmlns:a16="http://schemas.microsoft.com/office/drawing/2014/main" val="1257537633"/>
                  </a:ext>
                </a:extLst>
              </a:tr>
              <a:tr h="394983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Right eye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24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10 / 24 (42%)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7 / 24 (29%)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extLst>
                  <a:ext uri="{0D108BD9-81ED-4DB2-BD59-A6C34878D82A}">
                    <a16:rowId xmlns:a16="http://schemas.microsoft.com/office/drawing/2014/main" val="1874614380"/>
                  </a:ext>
                </a:extLst>
              </a:tr>
              <a:tr h="394983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Left eye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24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9 / 24 (38%)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6 / 24 (25%)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extLst>
                  <a:ext uri="{0D108BD9-81ED-4DB2-BD59-A6C34878D82A}">
                    <a16:rowId xmlns:a16="http://schemas.microsoft.com/office/drawing/2014/main" val="538475970"/>
                  </a:ext>
                </a:extLst>
              </a:tr>
              <a:tr h="698330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Either eye (eye-level total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48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>
                          <a:solidFill>
                            <a:srgbClr val="000000"/>
                          </a:solidFill>
                          <a:effectLst/>
                        </a:rPr>
                        <a:t>19 / 48 (40%)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3 / 48 (27%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anchor="b"/>
                </a:tc>
                <a:extLst>
                  <a:ext uri="{0D108BD9-81ED-4DB2-BD59-A6C34878D82A}">
                    <a16:rowId xmlns:a16="http://schemas.microsoft.com/office/drawing/2014/main" val="41922194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328358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4</TotalTime>
  <Words>559</Words>
  <Application>Microsoft Macintosh PowerPoint</Application>
  <PresentationFormat>Widescreen</PresentationFormat>
  <Paragraphs>155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ptos</vt:lpstr>
      <vt:lpstr>Aptos Display</vt:lpstr>
      <vt:lpstr>Aptos Narrow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omi Bennett</dc:creator>
  <cp:lastModifiedBy>Naomi Bennett</cp:lastModifiedBy>
  <cp:revision>40</cp:revision>
  <dcterms:created xsi:type="dcterms:W3CDTF">2025-12-24T00:16:59Z</dcterms:created>
  <dcterms:modified xsi:type="dcterms:W3CDTF">2026-03-02T03:27:50Z</dcterms:modified>
</cp:coreProperties>
</file>